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1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7642-3083-4072-9667-8D172224B4A0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7C3DD-187F-4572-B8F2-3ACD5560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283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7642-3083-4072-9667-8D172224B4A0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7C3DD-187F-4572-B8F2-3ACD5560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868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7642-3083-4072-9667-8D172224B4A0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7C3DD-187F-4572-B8F2-3ACD5560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991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7642-3083-4072-9667-8D172224B4A0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7C3DD-187F-4572-B8F2-3ACD5560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058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7642-3083-4072-9667-8D172224B4A0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7C3DD-187F-4572-B8F2-3ACD5560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901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7642-3083-4072-9667-8D172224B4A0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7C3DD-187F-4572-B8F2-3ACD5560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241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7642-3083-4072-9667-8D172224B4A0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7C3DD-187F-4572-B8F2-3ACD5560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187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7642-3083-4072-9667-8D172224B4A0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7C3DD-187F-4572-B8F2-3ACD5560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148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7642-3083-4072-9667-8D172224B4A0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7C3DD-187F-4572-B8F2-3ACD5560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850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7642-3083-4072-9667-8D172224B4A0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7C3DD-187F-4572-B8F2-3ACD5560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837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87642-3083-4072-9667-8D172224B4A0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7C3DD-187F-4572-B8F2-3ACD5560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0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F87642-3083-4072-9667-8D172224B4A0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7C3DD-187F-4572-B8F2-3ACD55609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368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A134462C-DADD-9942-85C4-13E20CC98F3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3013" r="69494" b="33513"/>
          <a:stretch/>
        </p:blipFill>
        <p:spPr>
          <a:xfrm>
            <a:off x="1495590" y="926671"/>
            <a:ext cx="3361220" cy="4220374"/>
          </a:xfrm>
          <a:prstGeom prst="rect">
            <a:avLst/>
          </a:prstGeom>
        </p:spPr>
      </p:pic>
      <p:pic>
        <p:nvPicPr>
          <p:cNvPr id="7" name="Picture 6" descr="A picture containing text&#10;&#10;Description automatically generated">
            <a:extLst>
              <a:ext uri="{FF2B5EF4-FFF2-40B4-BE49-F238E27FC236}">
                <a16:creationId xmlns:a16="http://schemas.microsoft.com/office/drawing/2014/main" id="{4597767D-329D-3B4B-867F-929F9AEE3E8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84576" b="96248"/>
          <a:stretch/>
        </p:blipFill>
        <p:spPr>
          <a:xfrm>
            <a:off x="1480550" y="5268349"/>
            <a:ext cx="1738869" cy="37267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ECD5D98-013A-9A49-ACCB-4753E0E16EAF}"/>
              </a:ext>
            </a:extLst>
          </p:cNvPr>
          <p:cNvSpPr txBox="1"/>
          <p:nvPr/>
        </p:nvSpPr>
        <p:spPr>
          <a:xfrm>
            <a:off x="1239329" y="5614114"/>
            <a:ext cx="227514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old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ang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∆</a:t>
            </a:r>
            <a:r>
              <a:rPr lang="en-US" sz="1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ltA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/wild-type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90735F2-B069-E443-8ABF-964760CCC7D5}"/>
              </a:ext>
            </a:extLst>
          </p:cNvPr>
          <p:cNvSpPr txBox="1"/>
          <p:nvPr/>
        </p:nvSpPr>
        <p:spPr>
          <a:xfrm>
            <a:off x="1630704" y="683089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f29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E00BE48-7228-5242-A87D-76AA8D0A63C9}"/>
              </a:ext>
            </a:extLst>
          </p:cNvPr>
          <p:cNvSpPr txBox="1"/>
          <p:nvPr/>
        </p:nvSpPr>
        <p:spPr>
          <a:xfrm>
            <a:off x="2369038" y="683089"/>
            <a:ext cx="7609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116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588F30C-C091-D14B-A091-26245B187C86}"/>
              </a:ext>
            </a:extLst>
          </p:cNvPr>
          <p:cNvSpPr txBox="1"/>
          <p:nvPr/>
        </p:nvSpPr>
        <p:spPr>
          <a:xfrm>
            <a:off x="483374" y="6949453"/>
            <a:ext cx="5630171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 Fig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ial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pression of select genes in a wild-type strain and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slt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train from each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A. fumigatu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ackground (Af293 </a:t>
            </a:r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A1160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uring growth in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MM containing low zinc and </a:t>
            </a:r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low nitrogen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alues represent Log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pression ratios for each gene in the ∆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slt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train divided by the wild-type strain as determined by RNA-seq (Af293) or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PCR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AF1160)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90735F2-B069-E443-8ABF-964760CCC7D5}"/>
              </a:ext>
            </a:extLst>
          </p:cNvPr>
          <p:cNvSpPr txBox="1"/>
          <p:nvPr/>
        </p:nvSpPr>
        <p:spPr>
          <a:xfrm>
            <a:off x="4844367" y="909253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ltA</a:t>
            </a:r>
            <a:endParaRPr 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90735F2-B069-E443-8ABF-964760CCC7D5}"/>
              </a:ext>
            </a:extLst>
          </p:cNvPr>
          <p:cNvSpPr txBox="1"/>
          <p:nvPr/>
        </p:nvSpPr>
        <p:spPr>
          <a:xfrm>
            <a:off x="4844367" y="1116922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spf1</a:t>
            </a:r>
            <a:endParaRPr 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90735F2-B069-E443-8ABF-964760CCC7D5}"/>
              </a:ext>
            </a:extLst>
          </p:cNvPr>
          <p:cNvSpPr txBox="1"/>
          <p:nvPr/>
        </p:nvSpPr>
        <p:spPr>
          <a:xfrm>
            <a:off x="4844367" y="1324591"/>
            <a:ext cx="6751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umR</a:t>
            </a:r>
            <a:endParaRPr 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90735F2-B069-E443-8ABF-964760CCC7D5}"/>
              </a:ext>
            </a:extLst>
          </p:cNvPr>
          <p:cNvSpPr txBox="1"/>
          <p:nvPr/>
        </p:nvSpPr>
        <p:spPr>
          <a:xfrm>
            <a:off x="4844367" y="1532259"/>
            <a:ext cx="777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ma</a:t>
            </a:r>
            <a:r>
              <a:rPr lang="en-US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9467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48</TotalTime>
  <Words>81</Words>
  <Application>Microsoft Office PowerPoint</Application>
  <PresentationFormat>Letter Paper (8.5x11 in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LA BioMedical Research Institute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ller, Scott</dc:creator>
  <cp:lastModifiedBy>Filler, Scott</cp:lastModifiedBy>
  <cp:revision>91</cp:revision>
  <cp:lastPrinted>2020-06-26T23:28:20Z</cp:lastPrinted>
  <dcterms:created xsi:type="dcterms:W3CDTF">2018-04-13T22:04:16Z</dcterms:created>
  <dcterms:modified xsi:type="dcterms:W3CDTF">2021-03-30T20:59:53Z</dcterms:modified>
</cp:coreProperties>
</file>